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56FC0B-F8B5-4C5F-A2B6-32345A49560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5B1C5D-2D1D-4EFB-9A62-7C5E072237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E1F5B8-B1DB-4377-9FDF-F6055AF705A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6C8341-CA05-4CAD-940D-944CE48F34E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E74BC9-D55D-42C3-BE37-61D6FB6780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D3FFA5-B517-4A03-A406-A8F0E20A40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4462B7-A238-4141-A13C-7746E21133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AAE108-0FEF-4B5F-A369-D557580F2A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AEF142-3F28-48A7-8597-B811D96FE9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D3E1D6-73E6-4129-8705-4105DCDE05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2419B0-DE1B-4E1A-875B-78ADBCFA48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7B6F46-33B4-4FF1-ABBA-71F5B06EE1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158E566-1590-4B99-8357-18CF3A14C5AC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205"/>
          <p:cNvSpPr/>
          <p:nvPr/>
        </p:nvSpPr>
        <p:spPr>
          <a:xfrm>
            <a:off x="3349800" y="468360"/>
            <a:ext cx="0" cy="82692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242"/>
          <p:cNvSpPr/>
          <p:nvPr/>
        </p:nvSpPr>
        <p:spPr>
          <a:xfrm>
            <a:off x="4869000" y="1006560"/>
            <a:ext cx="0" cy="718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72 Rectángulo redondeado"/>
          <p:cNvSpPr/>
          <p:nvPr/>
        </p:nvSpPr>
        <p:spPr>
          <a:xfrm>
            <a:off x="1695600" y="4932360"/>
            <a:ext cx="3143160" cy="3456000"/>
          </a:xfrm>
          <a:custGeom>
            <a:avLst/>
            <a:gdLst>
              <a:gd name="textAreaLeft" fmla="*/ 153360 w 3143160"/>
              <a:gd name="textAreaRight" fmla="*/ 2989800 w 3143160"/>
              <a:gd name="textAreaTop" fmla="*/ 153360 h 3456000"/>
              <a:gd name="textAreaBottom" fmla="*/ 3302640 h 3456000"/>
            </a:gdLst>
            <a:ahLst/>
            <a:rect l="textAreaLeft" t="textAreaTop" r="textAreaRight" b="textAreaBottom"/>
            <a:pathLst>
              <a:path w="21600" h="23750">
                <a:moveTo>
                  <a:pt x="3600" y="0"/>
                </a:moveTo>
                <a:arcTo wR="3600" hR="3600" stAng="16200000" swAng="-5400000"/>
                <a:lnTo>
                  <a:pt x="0" y="20150"/>
                </a:lnTo>
                <a:arcTo wR="3600" hR="3600" stAng="10800000" swAng="-5400000"/>
                <a:lnTo>
                  <a:pt x="18000" y="23750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2556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6"/>
          <p:cNvSpPr/>
          <p:nvPr/>
        </p:nvSpPr>
        <p:spPr>
          <a:xfrm>
            <a:off x="3057480" y="250920"/>
            <a:ext cx="649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GLC (E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8"/>
          <p:cNvSpPr/>
          <p:nvPr/>
        </p:nvSpPr>
        <p:spPr>
          <a:xfrm flipH="1">
            <a:off x="3343320" y="2433600"/>
            <a:ext cx="1440" cy="538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12"/>
          <p:cNvSpPr/>
          <p:nvPr/>
        </p:nvSpPr>
        <p:spPr>
          <a:xfrm>
            <a:off x="3129120" y="131904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G6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7"/>
          <p:cNvSpPr/>
          <p:nvPr/>
        </p:nvSpPr>
        <p:spPr>
          <a:xfrm>
            <a:off x="3176640" y="2211480"/>
            <a:ext cx="433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F6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8"/>
          <p:cNvSpPr/>
          <p:nvPr/>
        </p:nvSpPr>
        <p:spPr>
          <a:xfrm>
            <a:off x="3127320" y="2971800"/>
            <a:ext cx="432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GA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20"/>
          <p:cNvSpPr/>
          <p:nvPr/>
        </p:nvSpPr>
        <p:spPr>
          <a:xfrm>
            <a:off x="3129120" y="408924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PY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21"/>
          <p:cNvSpPr/>
          <p:nvPr/>
        </p:nvSpPr>
        <p:spPr>
          <a:xfrm>
            <a:off x="4653000" y="826920"/>
            <a:ext cx="503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RU5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24"/>
          <p:cNvSpPr/>
          <p:nvPr/>
        </p:nvSpPr>
        <p:spPr>
          <a:xfrm>
            <a:off x="4653000" y="1692360"/>
            <a:ext cx="444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XU5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25"/>
          <p:cNvSpPr/>
          <p:nvPr/>
        </p:nvSpPr>
        <p:spPr>
          <a:xfrm>
            <a:off x="5877000" y="169236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R5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27"/>
          <p:cNvSpPr/>
          <p:nvPr/>
        </p:nvSpPr>
        <p:spPr>
          <a:xfrm>
            <a:off x="5041080" y="1895760"/>
            <a:ext cx="1200240" cy="1548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28"/>
          <p:cNvSpPr/>
          <p:nvPr/>
        </p:nvSpPr>
        <p:spPr>
          <a:xfrm>
            <a:off x="6019920" y="2541600"/>
            <a:ext cx="649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ARA (E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32"/>
          <p:cNvSpPr/>
          <p:nvPr/>
        </p:nvSpPr>
        <p:spPr>
          <a:xfrm flipV="1">
            <a:off x="621720" y="2288520"/>
            <a:ext cx="9360" cy="69984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34"/>
          <p:cNvSpPr/>
          <p:nvPr/>
        </p:nvSpPr>
        <p:spPr>
          <a:xfrm>
            <a:off x="1557360" y="2975040"/>
            <a:ext cx="576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DHA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39"/>
          <p:cNvSpPr/>
          <p:nvPr/>
        </p:nvSpPr>
        <p:spPr>
          <a:xfrm>
            <a:off x="445680" y="2124000"/>
            <a:ext cx="385560" cy="15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GOL (E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61"/>
          <p:cNvSpPr/>
          <p:nvPr/>
        </p:nvSpPr>
        <p:spPr>
          <a:xfrm>
            <a:off x="3022560" y="5419800"/>
            <a:ext cx="647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ACCO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62"/>
          <p:cNvSpPr/>
          <p:nvPr/>
        </p:nvSpPr>
        <p:spPr>
          <a:xfrm>
            <a:off x="981000" y="4084560"/>
            <a:ext cx="432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OA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63"/>
          <p:cNvSpPr/>
          <p:nvPr/>
        </p:nvSpPr>
        <p:spPr>
          <a:xfrm>
            <a:off x="4076640" y="6431040"/>
            <a:ext cx="432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CI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64"/>
          <p:cNvSpPr/>
          <p:nvPr/>
        </p:nvSpPr>
        <p:spPr>
          <a:xfrm>
            <a:off x="4005360" y="7643880"/>
            <a:ext cx="43164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AK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65"/>
          <p:cNvSpPr/>
          <p:nvPr/>
        </p:nvSpPr>
        <p:spPr>
          <a:xfrm>
            <a:off x="2112840" y="7580160"/>
            <a:ext cx="432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MAL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69"/>
          <p:cNvSpPr/>
          <p:nvPr/>
        </p:nvSpPr>
        <p:spPr>
          <a:xfrm>
            <a:off x="2112840" y="6283440"/>
            <a:ext cx="432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OA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Arc 76"/>
          <p:cNvSpPr/>
          <p:nvPr/>
        </p:nvSpPr>
        <p:spPr>
          <a:xfrm rot="10612200">
            <a:off x="3354120" y="5624280"/>
            <a:ext cx="288720" cy="396720"/>
          </a:xfrm>
          <a:prstGeom prst="pie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rot="10800000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78"/>
          <p:cNvSpPr/>
          <p:nvPr/>
        </p:nvSpPr>
        <p:spPr>
          <a:xfrm>
            <a:off x="4508640" y="6556320"/>
            <a:ext cx="107784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80"/>
          <p:cNvSpPr/>
          <p:nvPr/>
        </p:nvSpPr>
        <p:spPr>
          <a:xfrm>
            <a:off x="3500280" y="4210200"/>
            <a:ext cx="7207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81"/>
          <p:cNvSpPr/>
          <p:nvPr/>
        </p:nvSpPr>
        <p:spPr>
          <a:xfrm>
            <a:off x="4221000" y="4084560"/>
            <a:ext cx="432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AC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82"/>
          <p:cNvSpPr/>
          <p:nvPr/>
        </p:nvSpPr>
        <p:spPr>
          <a:xfrm>
            <a:off x="5589720" y="4500720"/>
            <a:ext cx="647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ACCO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83"/>
          <p:cNvSpPr/>
          <p:nvPr/>
        </p:nvSpPr>
        <p:spPr>
          <a:xfrm>
            <a:off x="5589720" y="3622680"/>
            <a:ext cx="649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ETH (E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84"/>
          <p:cNvSpPr/>
          <p:nvPr/>
        </p:nvSpPr>
        <p:spPr>
          <a:xfrm>
            <a:off x="4608360" y="4225680"/>
            <a:ext cx="1025640" cy="4003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85"/>
          <p:cNvSpPr/>
          <p:nvPr/>
        </p:nvSpPr>
        <p:spPr>
          <a:xfrm flipH="1" flipV="1">
            <a:off x="2349000" y="3708360"/>
            <a:ext cx="825480" cy="39384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87"/>
          <p:cNvSpPr/>
          <p:nvPr/>
        </p:nvSpPr>
        <p:spPr>
          <a:xfrm>
            <a:off x="1844640" y="3551400"/>
            <a:ext cx="511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PYR (E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88"/>
          <p:cNvSpPr/>
          <p:nvPr/>
        </p:nvSpPr>
        <p:spPr>
          <a:xfrm flipV="1">
            <a:off x="4606920" y="3757320"/>
            <a:ext cx="1025640" cy="39996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Arc 89"/>
          <p:cNvSpPr/>
          <p:nvPr/>
        </p:nvSpPr>
        <p:spPr>
          <a:xfrm rot="12125400">
            <a:off x="1058040" y="3276360"/>
            <a:ext cx="3954600" cy="3273480"/>
          </a:xfrm>
          <a:prstGeom prst="pie">
            <a:avLst/>
          </a:prstGeom>
          <a:noFill/>
          <a:ln w="9360">
            <a:solidFill>
              <a:srgbClr val="000000"/>
            </a:solidFill>
            <a:round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rot="10800000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93"/>
          <p:cNvSpPr/>
          <p:nvPr/>
        </p:nvSpPr>
        <p:spPr>
          <a:xfrm>
            <a:off x="5657760" y="2975040"/>
            <a:ext cx="432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S7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94"/>
          <p:cNvSpPr/>
          <p:nvPr/>
        </p:nvSpPr>
        <p:spPr>
          <a:xfrm>
            <a:off x="4653000" y="221148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E4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83"/>
          <p:cNvSpPr/>
          <p:nvPr/>
        </p:nvSpPr>
        <p:spPr>
          <a:xfrm>
            <a:off x="5589720" y="6443640"/>
            <a:ext cx="649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CIT (E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64"/>
          <p:cNvSpPr/>
          <p:nvPr/>
        </p:nvSpPr>
        <p:spPr>
          <a:xfrm>
            <a:off x="5589720" y="7639200"/>
            <a:ext cx="43164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AK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Arc 89"/>
          <p:cNvSpPr/>
          <p:nvPr/>
        </p:nvSpPr>
        <p:spPr>
          <a:xfrm rot="12102000">
            <a:off x="1171080" y="3215880"/>
            <a:ext cx="3894120" cy="3276720"/>
          </a:xfrm>
          <a:prstGeom prst="pie">
            <a:avLst/>
          </a:prstGeom>
          <a:noFill/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rot="10800000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17"/>
          <p:cNvSpPr/>
          <p:nvPr/>
        </p:nvSpPr>
        <p:spPr>
          <a:xfrm>
            <a:off x="3414600" y="755640"/>
            <a:ext cx="86040" cy="16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10800" bIns="10800" anchor="t">
            <a:sp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x</a:t>
            </a:r>
            <a:r>
              <a:rPr b="0" i="1" lang="es-ES" sz="8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17"/>
          <p:cNvSpPr/>
          <p:nvPr/>
        </p:nvSpPr>
        <p:spPr>
          <a:xfrm>
            <a:off x="981000" y="1332000"/>
            <a:ext cx="714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Glycoge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17"/>
          <p:cNvSpPr/>
          <p:nvPr/>
        </p:nvSpPr>
        <p:spPr>
          <a:xfrm>
            <a:off x="3378960" y="1763640"/>
            <a:ext cx="122040" cy="16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x</a:t>
            </a:r>
            <a:r>
              <a:rPr b="0" i="1" lang="es-ES" sz="8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17"/>
          <p:cNvSpPr/>
          <p:nvPr/>
        </p:nvSpPr>
        <p:spPr>
          <a:xfrm>
            <a:off x="3395880" y="2381400"/>
            <a:ext cx="128160" cy="19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x</a:t>
            </a:r>
            <a:r>
              <a:rPr b="0" i="1" lang="es-ES" sz="10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17"/>
          <p:cNvSpPr/>
          <p:nvPr/>
        </p:nvSpPr>
        <p:spPr>
          <a:xfrm>
            <a:off x="2501280" y="2914560"/>
            <a:ext cx="122040" cy="16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x</a:t>
            </a:r>
            <a:r>
              <a:rPr b="0" i="1" lang="es-ES" sz="8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17"/>
          <p:cNvSpPr/>
          <p:nvPr/>
        </p:nvSpPr>
        <p:spPr>
          <a:xfrm>
            <a:off x="4149000" y="755640"/>
            <a:ext cx="122040" cy="16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x</a:t>
            </a:r>
            <a:r>
              <a:rPr b="0" i="1" lang="es-ES" sz="8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17"/>
          <p:cNvSpPr/>
          <p:nvPr/>
        </p:nvSpPr>
        <p:spPr>
          <a:xfrm>
            <a:off x="5468400" y="755640"/>
            <a:ext cx="122040" cy="16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x</a:t>
            </a:r>
            <a:r>
              <a:rPr b="0" i="1" lang="es-ES" sz="8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17"/>
          <p:cNvSpPr/>
          <p:nvPr/>
        </p:nvSpPr>
        <p:spPr>
          <a:xfrm>
            <a:off x="4892040" y="1258920"/>
            <a:ext cx="122040" cy="16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x</a:t>
            </a:r>
            <a:r>
              <a:rPr b="0" i="1" lang="es-ES" sz="8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17"/>
          <p:cNvSpPr/>
          <p:nvPr/>
        </p:nvSpPr>
        <p:spPr>
          <a:xfrm>
            <a:off x="5323680" y="2627280"/>
            <a:ext cx="122040" cy="16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x</a:t>
            </a:r>
            <a:r>
              <a:rPr b="0" i="1" lang="es-ES" sz="8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17"/>
          <p:cNvSpPr/>
          <p:nvPr/>
        </p:nvSpPr>
        <p:spPr>
          <a:xfrm>
            <a:off x="4425840" y="1906560"/>
            <a:ext cx="155520" cy="16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x</a:t>
            </a:r>
            <a:r>
              <a:rPr b="0" i="1" lang="es-ES" sz="8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1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17"/>
          <p:cNvSpPr/>
          <p:nvPr/>
        </p:nvSpPr>
        <p:spPr>
          <a:xfrm>
            <a:off x="4365720" y="2627280"/>
            <a:ext cx="155520" cy="16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x</a:t>
            </a:r>
            <a:r>
              <a:rPr b="0" i="1" lang="es-ES" sz="8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17"/>
          <p:cNvSpPr/>
          <p:nvPr/>
        </p:nvSpPr>
        <p:spPr>
          <a:xfrm>
            <a:off x="3403800" y="3533760"/>
            <a:ext cx="128160" cy="19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x</a:t>
            </a:r>
            <a:r>
              <a:rPr b="0" i="1" lang="es-ES" sz="10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17"/>
          <p:cNvSpPr/>
          <p:nvPr/>
        </p:nvSpPr>
        <p:spPr>
          <a:xfrm>
            <a:off x="3401280" y="4643280"/>
            <a:ext cx="164520" cy="19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x</a:t>
            </a:r>
            <a:r>
              <a:rPr b="0" i="1" lang="es-ES" sz="10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17"/>
          <p:cNvSpPr/>
          <p:nvPr/>
        </p:nvSpPr>
        <p:spPr>
          <a:xfrm>
            <a:off x="3723480" y="5867280"/>
            <a:ext cx="164520" cy="19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x</a:t>
            </a:r>
            <a:r>
              <a:rPr b="0" i="1" lang="es-ES" sz="10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17"/>
          <p:cNvSpPr/>
          <p:nvPr/>
        </p:nvSpPr>
        <p:spPr>
          <a:xfrm>
            <a:off x="4409280" y="6989760"/>
            <a:ext cx="164520" cy="19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x</a:t>
            </a:r>
            <a:r>
              <a:rPr b="0" i="1" lang="es-ES" sz="10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1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17"/>
          <p:cNvSpPr/>
          <p:nvPr/>
        </p:nvSpPr>
        <p:spPr>
          <a:xfrm>
            <a:off x="3185640" y="7997760"/>
            <a:ext cx="164520" cy="19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x</a:t>
            </a:r>
            <a:r>
              <a:rPr b="0" i="1" lang="es-ES" sz="10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1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17"/>
          <p:cNvSpPr/>
          <p:nvPr/>
        </p:nvSpPr>
        <p:spPr>
          <a:xfrm>
            <a:off x="2140920" y="6989760"/>
            <a:ext cx="164520" cy="19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x</a:t>
            </a:r>
            <a:r>
              <a:rPr b="0" i="1" lang="es-ES" sz="10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1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17"/>
          <p:cNvSpPr/>
          <p:nvPr/>
        </p:nvSpPr>
        <p:spPr>
          <a:xfrm>
            <a:off x="2120400" y="3995640"/>
            <a:ext cx="164520" cy="19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x</a:t>
            </a:r>
            <a:r>
              <a:rPr b="0" i="1" lang="es-ES" sz="10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1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17"/>
          <p:cNvSpPr/>
          <p:nvPr/>
        </p:nvSpPr>
        <p:spPr>
          <a:xfrm>
            <a:off x="3723480" y="3995640"/>
            <a:ext cx="164520" cy="19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x</a:t>
            </a:r>
            <a:r>
              <a:rPr b="0" i="1" lang="es-ES" sz="10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1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17"/>
          <p:cNvSpPr/>
          <p:nvPr/>
        </p:nvSpPr>
        <p:spPr>
          <a:xfrm>
            <a:off x="5057280" y="4211640"/>
            <a:ext cx="164520" cy="19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x</a:t>
            </a:r>
            <a:r>
              <a:rPr b="0" i="1" lang="es-ES" sz="10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1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17"/>
          <p:cNvSpPr/>
          <p:nvPr/>
        </p:nvSpPr>
        <p:spPr>
          <a:xfrm>
            <a:off x="5057280" y="3708360"/>
            <a:ext cx="164520" cy="19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x</a:t>
            </a:r>
            <a:r>
              <a:rPr b="0" i="1" lang="es-ES" sz="10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17"/>
          <p:cNvSpPr/>
          <p:nvPr/>
        </p:nvSpPr>
        <p:spPr>
          <a:xfrm>
            <a:off x="681120" y="2627280"/>
            <a:ext cx="155520" cy="16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x</a:t>
            </a:r>
            <a:r>
              <a:rPr b="0" i="1" lang="es-ES" sz="8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2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17"/>
          <p:cNvSpPr/>
          <p:nvPr/>
        </p:nvSpPr>
        <p:spPr>
          <a:xfrm>
            <a:off x="6297480" y="2124000"/>
            <a:ext cx="155520" cy="16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x</a:t>
            </a:r>
            <a:r>
              <a:rPr b="0" i="1" lang="es-ES" sz="8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2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17"/>
          <p:cNvSpPr/>
          <p:nvPr/>
        </p:nvSpPr>
        <p:spPr>
          <a:xfrm>
            <a:off x="1132920" y="4932360"/>
            <a:ext cx="164520" cy="19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x</a:t>
            </a:r>
            <a:r>
              <a:rPr b="0" i="1" lang="es-ES" sz="10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2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17"/>
          <p:cNvSpPr/>
          <p:nvPr/>
        </p:nvSpPr>
        <p:spPr>
          <a:xfrm>
            <a:off x="1491480" y="4757760"/>
            <a:ext cx="164520" cy="19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x</a:t>
            </a:r>
            <a:r>
              <a:rPr b="0" i="1" lang="es-ES" sz="10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2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17"/>
          <p:cNvSpPr/>
          <p:nvPr/>
        </p:nvSpPr>
        <p:spPr>
          <a:xfrm>
            <a:off x="5020560" y="7524720"/>
            <a:ext cx="164520" cy="19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x</a:t>
            </a:r>
            <a:r>
              <a:rPr b="0" i="1" lang="es-ES" sz="10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17"/>
          <p:cNvSpPr/>
          <p:nvPr/>
        </p:nvSpPr>
        <p:spPr>
          <a:xfrm>
            <a:off x="2716200" y="3679920"/>
            <a:ext cx="35244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x</a:t>
            </a:r>
            <a:r>
              <a:rPr b="0" i="1" lang="es-ES" sz="10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2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17"/>
          <p:cNvSpPr/>
          <p:nvPr/>
        </p:nvSpPr>
        <p:spPr>
          <a:xfrm>
            <a:off x="5020560" y="6343560"/>
            <a:ext cx="164520" cy="19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x</a:t>
            </a:r>
            <a:r>
              <a:rPr b="0" i="1" lang="es-ES" sz="10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2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17"/>
          <p:cNvSpPr/>
          <p:nvPr/>
        </p:nvSpPr>
        <p:spPr>
          <a:xfrm>
            <a:off x="2349360" y="1258920"/>
            <a:ext cx="155520" cy="16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x</a:t>
            </a:r>
            <a:r>
              <a:rPr b="0" i="1" lang="es-ES" sz="8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3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09" name="181 Conector recto de flecha"/>
          <p:cNvCxnSpPr>
            <a:stCxn id="49" idx="2"/>
            <a:endCxn id="58" idx="0"/>
          </p:cNvCxnSpPr>
          <p:nvPr/>
        </p:nvCxnSpPr>
        <p:spPr>
          <a:xfrm>
            <a:off x="3344760" y="4320360"/>
            <a:ext cx="1800" cy="10998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10" name="Text Box 39"/>
          <p:cNvSpPr/>
          <p:nvPr/>
        </p:nvSpPr>
        <p:spPr>
          <a:xfrm>
            <a:off x="423720" y="2967120"/>
            <a:ext cx="412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Calibri"/>
              </a:rPr>
              <a:t>GOL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17"/>
          <p:cNvSpPr/>
          <p:nvPr/>
        </p:nvSpPr>
        <p:spPr>
          <a:xfrm>
            <a:off x="1185840" y="2914560"/>
            <a:ext cx="155520" cy="16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x</a:t>
            </a:r>
            <a:r>
              <a:rPr b="0" i="1" lang="es-ES" sz="8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2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17"/>
          <p:cNvSpPr/>
          <p:nvPr/>
        </p:nvSpPr>
        <p:spPr>
          <a:xfrm rot="16200000">
            <a:off x="4377600" y="5469480"/>
            <a:ext cx="933480" cy="43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Mitochondri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ytosol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13" name="163 Conector angular"/>
          <p:cNvCxnSpPr/>
          <p:nvPr/>
        </p:nvCxnSpPr>
        <p:spPr>
          <a:xfrm>
            <a:off x="5032440" y="1812960"/>
            <a:ext cx="630720" cy="1318320"/>
          </a:xfrm>
          <a:prstGeom prst="bentConnector3">
            <a:avLst>
              <a:gd name="adj1" fmla="val 44031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14" name="165 Conector angular"/>
          <p:cNvCxnSpPr/>
          <p:nvPr/>
        </p:nvCxnSpPr>
        <p:spPr>
          <a:xfrm flipV="1" rot="10800000">
            <a:off x="3561480" y="1814040"/>
            <a:ext cx="2369520" cy="1318320"/>
          </a:xfrm>
          <a:prstGeom prst="bentConnector3">
            <a:avLst>
              <a:gd name="adj1" fmla="val 26272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15" name="175 Conector angular"/>
          <p:cNvCxnSpPr/>
          <p:nvPr/>
        </p:nvCxnSpPr>
        <p:spPr>
          <a:xfrm flipV="1">
            <a:off x="3578040" y="2339640"/>
            <a:ext cx="1122840" cy="720000"/>
          </a:xfrm>
          <a:prstGeom prst="bentConnector3">
            <a:avLst>
              <a:gd name="adj1" fmla="val 67318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16" name="178 Conector angular"/>
          <p:cNvCxnSpPr/>
          <p:nvPr/>
        </p:nvCxnSpPr>
        <p:spPr>
          <a:xfrm>
            <a:off x="3565080" y="2340000"/>
            <a:ext cx="2071080" cy="720000"/>
          </a:xfrm>
          <a:prstGeom prst="bentConnector3">
            <a:avLst>
              <a:gd name="adj1" fmla="val 36961"/>
            </a:avLst>
          </a:prstGeom>
          <a:ln w="9360">
            <a:solidFill>
              <a:srgbClr val="000000"/>
            </a:solidFill>
            <a:miter/>
            <a:headEnd len="med" type="triangle" w="med"/>
          </a:ln>
        </p:spPr>
      </p:cxnSp>
      <p:cxnSp>
        <p:nvCxnSpPr>
          <p:cNvPr id="117" name="187 Forma"/>
          <p:cNvCxnSpPr/>
          <p:nvPr/>
        </p:nvCxnSpPr>
        <p:spPr>
          <a:xfrm flipV="1" rot="16200000">
            <a:off x="4714560" y="2053800"/>
            <a:ext cx="126000" cy="183240"/>
          </a:xfrm>
          <a:prstGeom prst="bentConnector2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118" name="189 Forma"/>
          <p:cNvCxnSpPr/>
          <p:nvPr/>
        </p:nvCxnSpPr>
        <p:spPr>
          <a:xfrm rot="5400000">
            <a:off x="4616280" y="1826280"/>
            <a:ext cx="164160" cy="346680"/>
          </a:xfrm>
          <a:prstGeom prst="bentConnector2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119" name="198 Forma"/>
          <p:cNvCxnSpPr/>
          <p:nvPr/>
        </p:nvCxnSpPr>
        <p:spPr>
          <a:xfrm flipH="1" flipV="1" rot="5400000">
            <a:off x="3504960" y="2010960"/>
            <a:ext cx="892800" cy="1032480"/>
          </a:xfrm>
          <a:prstGeom prst="curvedConnector2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</p:cxnSp>
      <p:cxnSp>
        <p:nvCxnSpPr>
          <p:cNvPr id="120" name="205 Forma"/>
          <p:cNvCxnSpPr/>
          <p:nvPr/>
        </p:nvCxnSpPr>
        <p:spPr>
          <a:xfrm flipH="1" flipV="1" rot="5400000">
            <a:off x="3893760" y="1578240"/>
            <a:ext cx="132480" cy="1134360"/>
          </a:xfrm>
          <a:prstGeom prst="curvedConnector2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</p:cxnSp>
      <p:cxnSp>
        <p:nvCxnSpPr>
          <p:cNvPr id="121" name="110 Forma"/>
          <p:cNvCxnSpPr/>
          <p:nvPr/>
        </p:nvCxnSpPr>
        <p:spPr>
          <a:xfrm flipV="1" rot="10800000">
            <a:off x="1837440" y="2327760"/>
            <a:ext cx="1329480" cy="648360"/>
          </a:xfrm>
          <a:prstGeom prst="curvedConnector2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22" name="Text Box 17"/>
          <p:cNvSpPr/>
          <p:nvPr/>
        </p:nvSpPr>
        <p:spPr>
          <a:xfrm>
            <a:off x="2636280" y="2195640"/>
            <a:ext cx="122040" cy="16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000" rIns="18000" tIns="10800" bIns="10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x</a:t>
            </a:r>
            <a:r>
              <a:rPr b="0" i="1" lang="es-ES" sz="8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116"/>
          <p:cNvSpPr/>
          <p:nvPr/>
        </p:nvSpPr>
        <p:spPr>
          <a:xfrm flipH="1">
            <a:off x="1628640" y="1449360"/>
            <a:ext cx="1511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117"/>
          <p:cNvSpPr/>
          <p:nvPr/>
        </p:nvSpPr>
        <p:spPr>
          <a:xfrm>
            <a:off x="2060640" y="3087720"/>
            <a:ext cx="1116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120"/>
          <p:cNvSpPr/>
          <p:nvPr/>
        </p:nvSpPr>
        <p:spPr>
          <a:xfrm flipH="1">
            <a:off x="1413000" y="4211640"/>
            <a:ext cx="17287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Line 122"/>
          <p:cNvSpPr/>
          <p:nvPr/>
        </p:nvSpPr>
        <p:spPr>
          <a:xfrm>
            <a:off x="6243480" y="1908000"/>
            <a:ext cx="0" cy="64800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Arc 129"/>
          <p:cNvSpPr/>
          <p:nvPr/>
        </p:nvSpPr>
        <p:spPr>
          <a:xfrm flipH="1" rot="757800">
            <a:off x="2418120" y="5951520"/>
            <a:ext cx="1695600" cy="1131840"/>
          </a:xfrm>
          <a:prstGeom prst="pie">
            <a:avLst/>
          </a:prstGeom>
          <a:noFill/>
          <a:ln w="9360">
            <a:solidFill>
              <a:srgbClr val="000000"/>
            </a:solidFill>
            <a:round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Arc 130"/>
          <p:cNvSpPr/>
          <p:nvPr/>
        </p:nvSpPr>
        <p:spPr>
          <a:xfrm flipH="1" rot="757800">
            <a:off x="3252240" y="6603480"/>
            <a:ext cx="1123920" cy="912960"/>
          </a:xfrm>
          <a:prstGeom prst="pie">
            <a:avLst/>
          </a:prstGeom>
          <a:noFill/>
          <a:ln w="9360">
            <a:solidFill>
              <a:srgbClr val="000000"/>
            </a:solidFill>
            <a:round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Arc 131"/>
          <p:cNvSpPr/>
          <p:nvPr/>
        </p:nvSpPr>
        <p:spPr>
          <a:xfrm flipH="1" rot="757800">
            <a:off x="2412360" y="7105320"/>
            <a:ext cx="1673280" cy="1131840"/>
          </a:xfrm>
          <a:prstGeom prst="pie">
            <a:avLst/>
          </a:prstGeom>
          <a:noFill/>
          <a:ln w="9360">
            <a:solidFill>
              <a:srgbClr val="000000"/>
            </a:solidFill>
            <a:round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Arc 132"/>
          <p:cNvSpPr/>
          <p:nvPr/>
        </p:nvSpPr>
        <p:spPr>
          <a:xfrm flipH="1" rot="757800">
            <a:off x="2082240" y="6654600"/>
            <a:ext cx="1123920" cy="995040"/>
          </a:xfrm>
          <a:prstGeom prst="pie">
            <a:avLst/>
          </a:prstGeom>
          <a:noFill/>
          <a:ln w="9360">
            <a:solidFill>
              <a:srgbClr val="000000"/>
            </a:solidFill>
            <a:round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133"/>
          <p:cNvSpPr/>
          <p:nvPr/>
        </p:nvSpPr>
        <p:spPr>
          <a:xfrm>
            <a:off x="4365720" y="7758000"/>
            <a:ext cx="1224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204"/>
          <p:cNvSpPr/>
          <p:nvPr/>
        </p:nvSpPr>
        <p:spPr>
          <a:xfrm>
            <a:off x="3343320" y="3240000"/>
            <a:ext cx="0" cy="827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33" name="AutoShape 206"/>
          <p:cNvCxnSpPr>
            <a:stCxn id="46" idx="3"/>
            <a:endCxn id="50" idx="1"/>
          </p:cNvCxnSpPr>
          <p:nvPr/>
        </p:nvCxnSpPr>
        <p:spPr>
          <a:xfrm flipV="1">
            <a:off x="3560760" y="942480"/>
            <a:ext cx="1092600" cy="49248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34" name="AutoShape 207"/>
          <p:cNvCxnSpPr/>
          <p:nvPr/>
        </p:nvCxnSpPr>
        <p:spPr>
          <a:xfrm flipV="1" rot="16200000">
            <a:off x="5203440" y="826200"/>
            <a:ext cx="745200" cy="961200"/>
          </a:xfrm>
          <a:prstGeom prst="bentConnector2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</p:cxnSp>
      <p:sp>
        <p:nvSpPr>
          <p:cNvPr id="135" name="Line 241"/>
          <p:cNvSpPr/>
          <p:nvPr/>
        </p:nvSpPr>
        <p:spPr>
          <a:xfrm>
            <a:off x="3346560" y="1547640"/>
            <a:ext cx="0" cy="648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244"/>
          <p:cNvSpPr/>
          <p:nvPr/>
        </p:nvSpPr>
        <p:spPr>
          <a:xfrm flipH="1">
            <a:off x="801360" y="3094200"/>
            <a:ext cx="8269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9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16T16:30:34Z</dcterms:created>
  <dc:creator>kbaumann</dc:creator>
  <dc:description/>
  <dc:language>en-US</dc:language>
  <cp:lastModifiedBy>Kristin</cp:lastModifiedBy>
  <dcterms:modified xsi:type="dcterms:W3CDTF">2010-09-26T20:56:04Z</dcterms:modified>
  <cp:revision>28</cp:revision>
  <dc:subject/>
  <dc:title>Diapositiva 1</dc:title>
</cp:coreProperties>
</file>